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74" r:id="rId2"/>
    <p:sldId id="280" r:id="rId3"/>
    <p:sldId id="276" r:id="rId4"/>
    <p:sldId id="279" r:id="rId5"/>
    <p:sldId id="273" r:id="rId6"/>
    <p:sldId id="275" r:id="rId7"/>
    <p:sldId id="278" r:id="rId8"/>
  </p:sldIdLst>
  <p:sldSz cx="6858000" cy="9144000" type="screen4x3"/>
  <p:notesSz cx="7077075" cy="9363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CEF5FE76-36DB-436E-89E4-33E3A451B6C0}">
          <p14:sldIdLst>
            <p14:sldId id="274"/>
            <p14:sldId id="280"/>
            <p14:sldId id="276"/>
            <p14:sldId id="279"/>
            <p14:sldId id="273"/>
            <p14:sldId id="275"/>
            <p14:sldId id="278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itchell, Tanecia (Campus)" initials="MT(" lastIdx="5" clrIdx="0">
    <p:extLst>
      <p:ext uri="{19B8F6BF-5375-455C-9EA6-DF929625EA0E}">
        <p15:presenceInfo xmlns:p15="http://schemas.microsoft.com/office/powerpoint/2012/main" userId="S::taneciam@uab.edu::f57a2f70-8da8-45d8-9679-e930c331e09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33CC33"/>
    <a:srgbClr val="FFCC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533" autoAdjust="0"/>
    <p:restoredTop sz="96357" autoAdjust="0"/>
  </p:normalViewPr>
  <p:slideViewPr>
    <p:cSldViewPr>
      <p:cViewPr varScale="1">
        <p:scale>
          <a:sx n="87" d="100"/>
          <a:sy n="87" d="100"/>
        </p:scale>
        <p:origin x="3216" y="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6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image" Target="../media/image1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66733" cy="468154"/>
          </a:xfrm>
          <a:prstGeom prst="rect">
            <a:avLst/>
          </a:prstGeom>
        </p:spPr>
        <p:txBody>
          <a:bodyPr vert="horz" lIns="93936" tIns="46968" rIns="93936" bIns="46968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08705" y="0"/>
            <a:ext cx="3066733" cy="468154"/>
          </a:xfrm>
          <a:prstGeom prst="rect">
            <a:avLst/>
          </a:prstGeom>
        </p:spPr>
        <p:txBody>
          <a:bodyPr vert="horz" lIns="93936" tIns="46968" rIns="93936" bIns="46968" rtlCol="0"/>
          <a:lstStyle>
            <a:lvl1pPr algn="r">
              <a:defRPr sz="1200"/>
            </a:lvl1pPr>
          </a:lstStyle>
          <a:p>
            <a:fld id="{368F6DCA-BC21-4C8F-8226-69645B348CE2}" type="datetimeFigureOut">
              <a:rPr lang="en-US" smtClean="0"/>
              <a:t>2/3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20913" y="701675"/>
            <a:ext cx="2635250" cy="35115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936" tIns="46968" rIns="93936" bIns="46968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7708" y="4447461"/>
            <a:ext cx="5661660" cy="4213384"/>
          </a:xfrm>
          <a:prstGeom prst="rect">
            <a:avLst/>
          </a:prstGeom>
        </p:spPr>
        <p:txBody>
          <a:bodyPr vert="horz" lIns="93936" tIns="46968" rIns="93936" bIns="46968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93296"/>
            <a:ext cx="3066733" cy="468154"/>
          </a:xfrm>
          <a:prstGeom prst="rect">
            <a:avLst/>
          </a:prstGeom>
        </p:spPr>
        <p:txBody>
          <a:bodyPr vert="horz" lIns="93936" tIns="46968" rIns="93936" bIns="46968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08705" y="8893296"/>
            <a:ext cx="3066733" cy="468154"/>
          </a:xfrm>
          <a:prstGeom prst="rect">
            <a:avLst/>
          </a:prstGeom>
        </p:spPr>
        <p:txBody>
          <a:bodyPr vert="horz" lIns="93936" tIns="46968" rIns="93936" bIns="46968" rtlCol="0" anchor="b"/>
          <a:lstStyle>
            <a:lvl1pPr algn="r">
              <a:defRPr sz="1200"/>
            </a:lvl1pPr>
          </a:lstStyle>
          <a:p>
            <a:fld id="{643A84BB-930F-4BDB-9FA8-B2DCF305B2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17905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3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9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9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16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39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6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8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24592-2041-491B-99BB-1A5C5B28954E}" type="datetimeFigureOut">
              <a:rPr lang="en-US" smtClean="0"/>
              <a:t>2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9B4E8-3DB2-4378-8AB3-51EDB66C95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16301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24592-2041-491B-99BB-1A5C5B28954E}" type="datetimeFigureOut">
              <a:rPr lang="en-US" smtClean="0"/>
              <a:t>2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9B4E8-3DB2-4378-8AB3-51EDB66C95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84784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24592-2041-491B-99BB-1A5C5B28954E}" type="datetimeFigureOut">
              <a:rPr lang="en-US" smtClean="0"/>
              <a:t>2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9B4E8-3DB2-4378-8AB3-51EDB66C95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34562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24592-2041-491B-99BB-1A5C5B28954E}" type="datetimeFigureOut">
              <a:rPr lang="en-US" smtClean="0"/>
              <a:t>2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9B4E8-3DB2-4378-8AB3-51EDB66C95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47903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33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6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9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93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16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39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63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86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24592-2041-491B-99BB-1A5C5B28954E}" type="datetimeFigureOut">
              <a:rPr lang="en-US" smtClean="0"/>
              <a:t>2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9B4E8-3DB2-4378-8AB3-51EDB66C95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40530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2844802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1" y="2844802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24592-2041-491B-99BB-1A5C5B28954E}" type="datetimeFigureOut">
              <a:rPr lang="en-US" smtClean="0"/>
              <a:t>2/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9B4E8-3DB2-4378-8AB3-51EDB66C95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12416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33" indent="0">
              <a:buNone/>
              <a:defRPr sz="2000" b="1"/>
            </a:lvl2pPr>
            <a:lvl3pPr marL="914466" indent="0">
              <a:buNone/>
              <a:defRPr sz="1800" b="1"/>
            </a:lvl3pPr>
            <a:lvl4pPr marL="1371699" indent="0">
              <a:buNone/>
              <a:defRPr sz="1600" b="1"/>
            </a:lvl4pPr>
            <a:lvl5pPr marL="1828931" indent="0">
              <a:buNone/>
              <a:defRPr sz="1600" b="1"/>
            </a:lvl5pPr>
            <a:lvl6pPr marL="2286164" indent="0">
              <a:buNone/>
              <a:defRPr sz="1600" b="1"/>
            </a:lvl6pPr>
            <a:lvl7pPr marL="2743397" indent="0">
              <a:buNone/>
              <a:defRPr sz="1600" b="1"/>
            </a:lvl7pPr>
            <a:lvl8pPr marL="3200630" indent="0">
              <a:buNone/>
              <a:defRPr sz="1600" b="1"/>
            </a:lvl8pPr>
            <a:lvl9pPr marL="3657862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33" indent="0">
              <a:buNone/>
              <a:defRPr sz="2000" b="1"/>
            </a:lvl2pPr>
            <a:lvl3pPr marL="914466" indent="0">
              <a:buNone/>
              <a:defRPr sz="1800" b="1"/>
            </a:lvl3pPr>
            <a:lvl4pPr marL="1371699" indent="0">
              <a:buNone/>
              <a:defRPr sz="1600" b="1"/>
            </a:lvl4pPr>
            <a:lvl5pPr marL="1828931" indent="0">
              <a:buNone/>
              <a:defRPr sz="1600" b="1"/>
            </a:lvl5pPr>
            <a:lvl6pPr marL="2286164" indent="0">
              <a:buNone/>
              <a:defRPr sz="1600" b="1"/>
            </a:lvl6pPr>
            <a:lvl7pPr marL="2743397" indent="0">
              <a:buNone/>
              <a:defRPr sz="1600" b="1"/>
            </a:lvl7pPr>
            <a:lvl8pPr marL="3200630" indent="0">
              <a:buNone/>
              <a:defRPr sz="1600" b="1"/>
            </a:lvl8pPr>
            <a:lvl9pPr marL="3657862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24592-2041-491B-99BB-1A5C5B28954E}" type="datetimeFigureOut">
              <a:rPr lang="en-US" smtClean="0"/>
              <a:t>2/3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9B4E8-3DB2-4378-8AB3-51EDB66C95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49721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24592-2041-491B-99BB-1A5C5B28954E}" type="datetimeFigureOut">
              <a:rPr lang="en-US" smtClean="0"/>
              <a:t>2/3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9B4E8-3DB2-4378-8AB3-51EDB66C95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2598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24592-2041-491B-99BB-1A5C5B28954E}" type="datetimeFigureOut">
              <a:rPr lang="en-US" smtClean="0"/>
              <a:t>2/3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9B4E8-3DB2-4378-8AB3-51EDB66C95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36711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33" indent="0">
              <a:buNone/>
              <a:defRPr sz="1200"/>
            </a:lvl2pPr>
            <a:lvl3pPr marL="914466" indent="0">
              <a:buNone/>
              <a:defRPr sz="1000"/>
            </a:lvl3pPr>
            <a:lvl4pPr marL="1371699" indent="0">
              <a:buNone/>
              <a:defRPr sz="900"/>
            </a:lvl4pPr>
            <a:lvl5pPr marL="1828931" indent="0">
              <a:buNone/>
              <a:defRPr sz="900"/>
            </a:lvl5pPr>
            <a:lvl6pPr marL="2286164" indent="0">
              <a:buNone/>
              <a:defRPr sz="900"/>
            </a:lvl6pPr>
            <a:lvl7pPr marL="2743397" indent="0">
              <a:buNone/>
              <a:defRPr sz="900"/>
            </a:lvl7pPr>
            <a:lvl8pPr marL="3200630" indent="0">
              <a:buNone/>
              <a:defRPr sz="900"/>
            </a:lvl8pPr>
            <a:lvl9pPr marL="3657862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24592-2041-491B-99BB-1A5C5B28954E}" type="datetimeFigureOut">
              <a:rPr lang="en-US" smtClean="0"/>
              <a:t>2/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9B4E8-3DB2-4378-8AB3-51EDB66C95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93695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2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33" indent="0">
              <a:buNone/>
              <a:defRPr sz="2800"/>
            </a:lvl2pPr>
            <a:lvl3pPr marL="914466" indent="0">
              <a:buNone/>
              <a:defRPr sz="2400"/>
            </a:lvl3pPr>
            <a:lvl4pPr marL="1371699" indent="0">
              <a:buNone/>
              <a:defRPr sz="2000"/>
            </a:lvl4pPr>
            <a:lvl5pPr marL="1828931" indent="0">
              <a:buNone/>
              <a:defRPr sz="2000"/>
            </a:lvl5pPr>
            <a:lvl6pPr marL="2286164" indent="0">
              <a:buNone/>
              <a:defRPr sz="2000"/>
            </a:lvl6pPr>
            <a:lvl7pPr marL="2743397" indent="0">
              <a:buNone/>
              <a:defRPr sz="2000"/>
            </a:lvl7pPr>
            <a:lvl8pPr marL="3200630" indent="0">
              <a:buNone/>
              <a:defRPr sz="2000"/>
            </a:lvl8pPr>
            <a:lvl9pPr marL="3657862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3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33" indent="0">
              <a:buNone/>
              <a:defRPr sz="1200"/>
            </a:lvl2pPr>
            <a:lvl3pPr marL="914466" indent="0">
              <a:buNone/>
              <a:defRPr sz="1000"/>
            </a:lvl3pPr>
            <a:lvl4pPr marL="1371699" indent="0">
              <a:buNone/>
              <a:defRPr sz="900"/>
            </a:lvl4pPr>
            <a:lvl5pPr marL="1828931" indent="0">
              <a:buNone/>
              <a:defRPr sz="900"/>
            </a:lvl5pPr>
            <a:lvl6pPr marL="2286164" indent="0">
              <a:buNone/>
              <a:defRPr sz="900"/>
            </a:lvl6pPr>
            <a:lvl7pPr marL="2743397" indent="0">
              <a:buNone/>
              <a:defRPr sz="900"/>
            </a:lvl7pPr>
            <a:lvl8pPr marL="3200630" indent="0">
              <a:buNone/>
              <a:defRPr sz="900"/>
            </a:lvl8pPr>
            <a:lvl9pPr marL="3657862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24592-2041-491B-99BB-1A5C5B28954E}" type="datetimeFigureOut">
              <a:rPr lang="en-US" smtClean="0"/>
              <a:t>2/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9B4E8-3DB2-4378-8AB3-51EDB66C95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26566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3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E24592-2041-491B-99BB-1A5C5B28954E}" type="datetimeFigureOut">
              <a:rPr lang="en-US" smtClean="0"/>
              <a:t>2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39B4E8-3DB2-4378-8AB3-51EDB66C95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8094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66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25" indent="-342925" algn="l" defTabSz="914466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3003" indent="-285771" algn="l" defTabSz="914466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82" indent="-228616" algn="l" defTabSz="914466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315" indent="-228616" algn="l" defTabSz="914466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548" indent="-228616" algn="l" defTabSz="914466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781" indent="-228616" algn="l" defTabSz="914466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2013" indent="-228616" algn="l" defTabSz="914466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246" indent="-228616" algn="l" defTabSz="914466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479" indent="-228616" algn="l" defTabSz="914466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6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33" algn="l" defTabSz="91446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66" algn="l" defTabSz="91446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99" algn="l" defTabSz="91446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931" algn="l" defTabSz="91446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164" algn="l" defTabSz="91446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397" algn="l" defTabSz="91446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630" algn="l" defTabSz="91446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862" algn="l" defTabSz="91446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7.png"/><Relationship Id="rId7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0.emf"/><Relationship Id="rId5" Type="http://schemas.openxmlformats.org/officeDocument/2006/relationships/image" Target="../media/image9.emf"/><Relationship Id="rId4" Type="http://schemas.openxmlformats.org/officeDocument/2006/relationships/image" Target="../media/image8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12.emf"/><Relationship Id="rId5" Type="http://schemas.openxmlformats.org/officeDocument/2006/relationships/oleObject" Target="../embeddings/oleObject3.bin"/><Relationship Id="rId4" Type="http://schemas.openxmlformats.org/officeDocument/2006/relationships/image" Target="../media/image1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-50180" y="273321"/>
            <a:ext cx="17570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 1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29323" y="661942"/>
            <a:ext cx="32880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re-designed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Taqman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primers used for RT-qPCR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-68446" y="638859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0AF9008-1085-4491-B21F-C60B33BC34C4}"/>
              </a:ext>
            </a:extLst>
          </p:cNvPr>
          <p:cNvSpPr txBox="1"/>
          <p:nvPr/>
        </p:nvSpPr>
        <p:spPr>
          <a:xfrm>
            <a:off x="-50180" y="26972"/>
            <a:ext cx="18741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DAT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5FF900A-4566-48BD-BFBA-E349A4551914}"/>
              </a:ext>
            </a:extLst>
          </p:cNvPr>
          <p:cNvSpPr txBox="1"/>
          <p:nvPr/>
        </p:nvSpPr>
        <p:spPr>
          <a:xfrm>
            <a:off x="261997" y="4041155"/>
            <a:ext cx="20569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rimers used for CHIP-qPCR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68A7078-6BF8-471A-AF1E-F2F284A03A69}"/>
              </a:ext>
            </a:extLst>
          </p:cNvPr>
          <p:cNvSpPr txBox="1"/>
          <p:nvPr/>
        </p:nvSpPr>
        <p:spPr>
          <a:xfrm>
            <a:off x="-27334" y="402456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30968605"/>
              </p:ext>
            </p:extLst>
          </p:nvPr>
        </p:nvGraphicFramePr>
        <p:xfrm>
          <a:off x="280412" y="1066800"/>
          <a:ext cx="2324100" cy="252793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89000">
                  <a:extLst>
                    <a:ext uri="{9D8B030D-6E8A-4147-A177-3AD203B41FA5}">
                      <a16:colId xmlns:a16="http://schemas.microsoft.com/office/drawing/2014/main" val="1203588110"/>
                    </a:ext>
                  </a:extLst>
                </a:gridCol>
                <a:gridCol w="1435100">
                  <a:extLst>
                    <a:ext uri="{9D8B030D-6E8A-4147-A177-3AD203B41FA5}">
                      <a16:colId xmlns:a16="http://schemas.microsoft.com/office/drawing/2014/main" val="1305346193"/>
                    </a:ext>
                  </a:extLst>
                </a:gridCol>
              </a:tblGrid>
              <a:tr h="17526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ME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SAY ID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72236529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PARGC1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00173304_m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71994752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O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00426616_g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68948392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GDH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01081865_m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42632267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CLG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00388749_m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29545061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H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00938918_m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7064324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00264683_m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07473741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CLG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00896917_g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59352674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H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00818427_m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94931905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IF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00904994_g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1480566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DAC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02621185_s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39570266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DAC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00248789_m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11591549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LP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 99999902_ m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87567636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BP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00427620_m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14410710"/>
                  </a:ext>
                </a:extLst>
              </a:tr>
            </a:tbl>
          </a:graphicData>
        </a:graphic>
      </p:graphicFrame>
      <p:graphicFrame>
        <p:nvGraphicFramePr>
          <p:cNvPr id="13" name="Table 1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96888080"/>
              </p:ext>
            </p:extLst>
          </p:nvPr>
        </p:nvGraphicFramePr>
        <p:xfrm>
          <a:off x="243240" y="4419601"/>
          <a:ext cx="4076700" cy="1990725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1154801">
                  <a:extLst>
                    <a:ext uri="{9D8B030D-6E8A-4147-A177-3AD203B41FA5}">
                      <a16:colId xmlns:a16="http://schemas.microsoft.com/office/drawing/2014/main" val="410876504"/>
                    </a:ext>
                  </a:extLst>
                </a:gridCol>
                <a:gridCol w="2921899">
                  <a:extLst>
                    <a:ext uri="{9D8B030D-6E8A-4147-A177-3AD203B41FA5}">
                      <a16:colId xmlns:a16="http://schemas.microsoft.com/office/drawing/2014/main" val="3343447977"/>
                    </a:ext>
                  </a:extLst>
                </a:gridCol>
              </a:tblGrid>
              <a:tr h="18097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CLG-154F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TGTTAATCAAACCCACATTTCTAGG-3’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85598382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CLG-154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AGGGTGGCCACAGCAGTC-3’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298795895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30952554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CLG(-274F)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ATGGGCCTGGGATACAAAGT-3’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877012435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CLG(-274R)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GGCATTGTGGGCAATGTAGT-3’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39063761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914724983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CLG1(-341F)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AGTTCTGGCACTGCTCTTCG-3’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66449736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CLG1(-341R)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GTGGGCAATGTAGTCTGACG-3’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366967625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521405250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CLG1 (-581F)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CAGGGAATAAACACTCATGCAC-3’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284645335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CLG1 (-581R)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GAATTCGAACTGGCACTGGT-3’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69296554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722620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-50180" y="273321"/>
            <a:ext cx="17570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 2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D0AF9008-1085-4491-B21F-C60B33BC34C4}"/>
              </a:ext>
            </a:extLst>
          </p:cNvPr>
          <p:cNvSpPr txBox="1"/>
          <p:nvPr/>
        </p:nvSpPr>
        <p:spPr>
          <a:xfrm>
            <a:off x="-50180" y="26972"/>
            <a:ext cx="18741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DATA</a:t>
            </a:r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09717916"/>
              </p:ext>
            </p:extLst>
          </p:nvPr>
        </p:nvGraphicFramePr>
        <p:xfrm>
          <a:off x="168812" y="4012931"/>
          <a:ext cx="4849374" cy="1993860"/>
        </p:xfrm>
        <a:graphic>
          <a:graphicData uri="http://schemas.openxmlformats.org/drawingml/2006/table">
            <a:tbl>
              <a:tblPr>
                <a:tableStyleId>{073A0DAA-6AF3-43AB-8588-CEC1D06C72B9}</a:tableStyleId>
              </a:tblPr>
              <a:tblGrid>
                <a:gridCol w="940322">
                  <a:extLst>
                    <a:ext uri="{9D8B030D-6E8A-4147-A177-3AD203B41FA5}">
                      <a16:colId xmlns:a16="http://schemas.microsoft.com/office/drawing/2014/main" val="1062689242"/>
                    </a:ext>
                  </a:extLst>
                </a:gridCol>
                <a:gridCol w="1517948">
                  <a:extLst>
                    <a:ext uri="{9D8B030D-6E8A-4147-A177-3AD203B41FA5}">
                      <a16:colId xmlns:a16="http://schemas.microsoft.com/office/drawing/2014/main" val="293547105"/>
                    </a:ext>
                  </a:extLst>
                </a:gridCol>
                <a:gridCol w="2391104">
                  <a:extLst>
                    <a:ext uri="{9D8B030D-6E8A-4147-A177-3AD203B41FA5}">
                      <a16:colId xmlns:a16="http://schemas.microsoft.com/office/drawing/2014/main" val="2258936711"/>
                    </a:ext>
                  </a:extLst>
                </a:gridCol>
              </a:tblGrid>
              <a:tr h="19938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bodies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ecies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erence number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967335"/>
                  </a:ext>
                </a:extLst>
              </a:tr>
              <a:tr h="19938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GC1</a:t>
                      </a:r>
                      <a:r>
                        <a:rPr lang="el-GR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  <a:endParaRPr lang="el-GR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bbit polyclonal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BP1-04676S (Novus Biological)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23601483"/>
                  </a:ext>
                </a:extLst>
              </a:tr>
              <a:tr h="19938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O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bbit polyclona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922S (Cell Signaling)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28636627"/>
                  </a:ext>
                </a:extLst>
              </a:tr>
              <a:tr h="19938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CLG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bbit polyclona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57S (Cell Signaling)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54812928"/>
                  </a:ext>
                </a:extLst>
              </a:tr>
              <a:tr h="19938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 monoclonal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-100743 (Santa Cruz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23685259"/>
                  </a:ext>
                </a:extLst>
              </a:tr>
              <a:tr h="19938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CLG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bbit polyclona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BP1-32521 (Novus Biologicals)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35020913"/>
                  </a:ext>
                </a:extLst>
              </a:tr>
              <a:tr h="19938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1A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heep polyclona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F6220 (Novus Biological)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21398784"/>
                  </a:ext>
                </a:extLst>
              </a:tr>
              <a:tr h="19938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6A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bbit polyclona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853-1-AP (Proteintech)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63946971"/>
                  </a:ext>
                </a:extLst>
              </a:tr>
              <a:tr h="19938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DAC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 monoclona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-81598x (Santa Cruz)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77211747"/>
                  </a:ext>
                </a:extLst>
              </a:tr>
              <a:tr h="19938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DAC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 monoclonal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-74563x (Santa Cruz)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99756271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223940" y="3650633"/>
            <a:ext cx="236955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ist of antibodies used in this study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0" y="705898"/>
            <a:ext cx="277511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 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rimers used for mitochondrial content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13962" y="3650633"/>
            <a:ext cx="29527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8DA7D140-564B-4B03-9397-9DB45071AD1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63453126"/>
              </p:ext>
            </p:extLst>
          </p:nvPr>
        </p:nvGraphicFramePr>
        <p:xfrm>
          <a:off x="168812" y="1076947"/>
          <a:ext cx="4090108" cy="181951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346908">
                  <a:extLst>
                    <a:ext uri="{9D8B030D-6E8A-4147-A177-3AD203B41FA5}">
                      <a16:colId xmlns:a16="http://schemas.microsoft.com/office/drawing/2014/main" val="1543665421"/>
                    </a:ext>
                  </a:extLst>
                </a:gridCol>
                <a:gridCol w="2743200">
                  <a:extLst>
                    <a:ext uri="{9D8B030D-6E8A-4147-A177-3AD203B41FA5}">
                      <a16:colId xmlns:a16="http://schemas.microsoft.com/office/drawing/2014/main" val="3711023364"/>
                    </a:ext>
                  </a:extLst>
                </a:gridCol>
              </a:tblGrid>
              <a:tr h="2517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me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277" marR="6277" marT="627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quence (5'-3')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277" marR="6277" marT="627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62524181"/>
                  </a:ext>
                </a:extLst>
              </a:tr>
              <a:tr h="26129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-Loop-F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277" marR="6277" marT="627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TTTGGGTACCACCCAAGTATT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277" marR="6277" marT="627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72020428"/>
                  </a:ext>
                </a:extLst>
              </a:tr>
              <a:tr h="26129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-Loop-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277" marR="6277" marT="627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ACAATATTCATGGTGGCTGGCA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277" marR="6277" marT="627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30647347"/>
                  </a:ext>
                </a:extLst>
              </a:tr>
              <a:tr h="26129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T-CO2-F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277" marR="6277" marT="627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TGCGACTCCTTGACGTTG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277" marR="6277" marT="627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11193063"/>
                  </a:ext>
                </a:extLst>
              </a:tr>
              <a:tr h="26129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T-CO2-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277" marR="6277" marT="627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CGGTGAAAGTGGTTTGGT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277" marR="6277" marT="627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43146523"/>
                  </a:ext>
                </a:extLst>
              </a:tr>
              <a:tr h="26129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eta-actin(DNA)-F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277" marR="6277" marT="627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ACCCACACTGTGCCCATCTACG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277" marR="6277" marT="627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77328530"/>
                  </a:ext>
                </a:extLst>
              </a:tr>
              <a:tr h="26129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eta-actin(DNA)-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277" marR="6277" marT="627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GCGGAACCGCTCATTGCCAATGG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277" marR="6277" marT="627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5677784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3586220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87067509"/>
              </p:ext>
            </p:extLst>
          </p:nvPr>
        </p:nvGraphicFramePr>
        <p:xfrm>
          <a:off x="295274" y="1208446"/>
          <a:ext cx="3869689" cy="1802831"/>
        </p:xfrm>
        <a:graphic>
          <a:graphicData uri="http://schemas.openxmlformats.org/drawingml/2006/table">
            <a:tbl>
              <a:tblPr/>
              <a:tblGrid>
                <a:gridCol w="499315">
                  <a:extLst>
                    <a:ext uri="{9D8B030D-6E8A-4147-A177-3AD203B41FA5}">
                      <a16:colId xmlns:a16="http://schemas.microsoft.com/office/drawing/2014/main" val="473152485"/>
                    </a:ext>
                  </a:extLst>
                </a:gridCol>
                <a:gridCol w="2191437">
                  <a:extLst>
                    <a:ext uri="{9D8B030D-6E8A-4147-A177-3AD203B41FA5}">
                      <a16:colId xmlns:a16="http://schemas.microsoft.com/office/drawing/2014/main" val="4141422480"/>
                    </a:ext>
                  </a:extLst>
                </a:gridCol>
                <a:gridCol w="540925">
                  <a:extLst>
                    <a:ext uri="{9D8B030D-6E8A-4147-A177-3AD203B41FA5}">
                      <a16:colId xmlns:a16="http://schemas.microsoft.com/office/drawing/2014/main" val="843049136"/>
                    </a:ext>
                  </a:extLst>
                </a:gridCol>
                <a:gridCol w="638012">
                  <a:extLst>
                    <a:ext uri="{9D8B030D-6E8A-4147-A177-3AD203B41FA5}">
                      <a16:colId xmlns:a16="http://schemas.microsoft.com/office/drawing/2014/main" val="631619398"/>
                    </a:ext>
                  </a:extLst>
                </a:gridCol>
              </a:tblGrid>
              <a:tr h="163830"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TGIF2 </a:t>
                      </a:r>
                      <a:r>
                        <a:rPr lang="en-US" sz="1000" b="1" i="0" u="none" strike="noStrike" dirty="0" err="1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anticorrelated</a:t>
                      </a:r>
                      <a:r>
                        <a:rPr lang="en-US" sz="10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 genes in RC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27642950"/>
                  </a:ext>
                </a:extLst>
              </a:tr>
              <a:tr h="38640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ank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ene se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-valu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djusted   P-Valu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27173108"/>
                  </a:ext>
                </a:extLst>
              </a:tr>
              <a:tr h="1638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FF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FF"/>
                          </a:solidFill>
                          <a:effectLst/>
                          <a:latin typeface="Arial" panose="020B0604020202020204" pitchFamily="34" charset="0"/>
                        </a:rPr>
                        <a:t>CITRATE CYCLE TCA CYCL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FF"/>
                          </a:solidFill>
                          <a:effectLst/>
                          <a:latin typeface="Arial" panose="020B0604020202020204" pitchFamily="34" charset="0"/>
                        </a:rPr>
                        <a:t>3.22e-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FF"/>
                          </a:solidFill>
                          <a:effectLst/>
                          <a:latin typeface="Arial" panose="020B0604020202020204" pitchFamily="34" charset="0"/>
                        </a:rPr>
                        <a:t>5.32e-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85388106"/>
                  </a:ext>
                </a:extLst>
              </a:tr>
              <a:tr h="19265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FF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FF"/>
                          </a:solidFill>
                          <a:effectLst/>
                          <a:latin typeface="Arial" panose="020B0604020202020204" pitchFamily="34" charset="0"/>
                        </a:rPr>
                        <a:t>OXIDATIVE PHOSPHORYLATIO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FF"/>
                          </a:solidFill>
                          <a:effectLst/>
                          <a:latin typeface="Arial" panose="020B0604020202020204" pitchFamily="34" charset="0"/>
                        </a:rPr>
                        <a:t>5.72e-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FF"/>
                          </a:solidFill>
                          <a:effectLst/>
                          <a:latin typeface="Arial" panose="020B0604020202020204" pitchFamily="34" charset="0"/>
                        </a:rPr>
                        <a:t>5.32e-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53580652"/>
                  </a:ext>
                </a:extLst>
              </a:tr>
              <a:tr h="19265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ATTY ACID METABOLISM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64e-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66e-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22517719"/>
                  </a:ext>
                </a:extLst>
              </a:tr>
              <a:tr h="19265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PANOATE METABOLISM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76E-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.18E-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35446302"/>
                  </a:ext>
                </a:extLst>
              </a:tr>
              <a:tr h="19265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ARKINSONS DISEAS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.23E-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77E-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77754562"/>
                  </a:ext>
                </a:extLst>
              </a:tr>
              <a:tr h="31813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CAA DEGRADATION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.93E-0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77E-0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89206748"/>
                  </a:ext>
                </a:extLst>
              </a:tr>
            </a:tbl>
          </a:graphicData>
        </a:graphic>
      </p:graphicFrame>
      <p:sp>
        <p:nvSpPr>
          <p:cNvPr id="23" name="TextBox 22"/>
          <p:cNvSpPr txBox="1"/>
          <p:nvPr/>
        </p:nvSpPr>
        <p:spPr>
          <a:xfrm>
            <a:off x="48990" y="617709"/>
            <a:ext cx="56740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TGIF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ti-correlated genes. TCGA data were analyzed using the GRACE tool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nd assessed for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TGIF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ti-correlated gene sets with KEGG pathway analysis. 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-50180" y="273321"/>
            <a:ext cx="17570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 3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0AF9008-1085-4491-B21F-C60B33BC34C4}"/>
              </a:ext>
            </a:extLst>
          </p:cNvPr>
          <p:cNvSpPr txBox="1"/>
          <p:nvPr/>
        </p:nvSpPr>
        <p:spPr>
          <a:xfrm>
            <a:off x="-50180" y="26972"/>
            <a:ext cx="18741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DATA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" y="3962400"/>
            <a:ext cx="675759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HDAC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nti-correlated genes. TCGA data were analyzed using the GRACE tool and assessed for HDAC anti-correlated gene sets with KEGG pathway analysis. 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45" y="4686687"/>
            <a:ext cx="6446255" cy="17677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536512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0AF9008-1085-4491-B21F-C60B33BC34C4}"/>
              </a:ext>
            </a:extLst>
          </p:cNvPr>
          <p:cNvSpPr txBox="1"/>
          <p:nvPr/>
        </p:nvSpPr>
        <p:spPr>
          <a:xfrm>
            <a:off x="4733" y="32706"/>
            <a:ext cx="18741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DATA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4129" y="279143"/>
            <a:ext cx="18373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889"/>
          <a:stretch/>
        </p:blipFill>
        <p:spPr>
          <a:xfrm>
            <a:off x="304800" y="1046627"/>
            <a:ext cx="5702581" cy="1855866"/>
          </a:xfrm>
          <a:prstGeom prst="rect">
            <a:avLst/>
          </a:prstGeom>
        </p:spPr>
      </p:pic>
      <p:sp>
        <p:nvSpPr>
          <p:cNvPr id="25" name="TextBox 24"/>
          <p:cNvSpPr txBox="1"/>
          <p:nvPr/>
        </p:nvSpPr>
        <p:spPr>
          <a:xfrm>
            <a:off x="304800" y="3128524"/>
            <a:ext cx="5562541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. S1. The protein expression of TCA cycle enzymes is lost in </a:t>
            </a:r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ccRCC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Protein expression of OGDH across pan-cancer subtypes from the CPTAC cohorts. Data were analyzed with the UALCAN analysis portal. </a:t>
            </a:r>
          </a:p>
          <a:p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91568" y="1598915"/>
            <a:ext cx="254995" cy="914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TextBox 15"/>
          <p:cNvSpPr txBox="1"/>
          <p:nvPr/>
        </p:nvSpPr>
        <p:spPr>
          <a:xfrm rot="16200000">
            <a:off x="-244834" y="1795710"/>
            <a:ext cx="922621" cy="205178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OGDH protein expression 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(Z-value)</a:t>
            </a:r>
          </a:p>
        </p:txBody>
      </p:sp>
      <p:sp>
        <p:nvSpPr>
          <p:cNvPr id="3" name="Rectangle 2"/>
          <p:cNvSpPr/>
          <p:nvPr/>
        </p:nvSpPr>
        <p:spPr>
          <a:xfrm>
            <a:off x="943930" y="2667000"/>
            <a:ext cx="5016781" cy="3048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51BBC73-CB55-45E9-A5C7-62A1B3AB95F6}"/>
              </a:ext>
            </a:extLst>
          </p:cNvPr>
          <p:cNvSpPr txBox="1"/>
          <p:nvPr/>
        </p:nvSpPr>
        <p:spPr>
          <a:xfrm>
            <a:off x="685800" y="2621618"/>
            <a:ext cx="52822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N                T              N              T               N              T              N               T               N               T   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897260" y="2811887"/>
            <a:ext cx="5116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Breast 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ancer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2001399" y="2819400"/>
            <a:ext cx="5116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olon 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ancer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3086070" y="2845937"/>
            <a:ext cx="5453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Ovarian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ancer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4114800" y="2839897"/>
            <a:ext cx="5164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Kidney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ancer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5125408" y="2819400"/>
            <a:ext cx="5164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Uterine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ancer</a:t>
            </a:r>
          </a:p>
        </p:txBody>
      </p:sp>
    </p:spTree>
    <p:extLst>
      <p:ext uri="{BB962C8B-B14F-4D97-AF65-F5344CB8AC3E}">
        <p14:creationId xmlns:p14="http://schemas.microsoft.com/office/powerpoint/2010/main" val="142075774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31475" y="239748"/>
            <a:ext cx="18373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D2297E1-962D-4C39-ADC2-16E0F93E55E5}"/>
              </a:ext>
            </a:extLst>
          </p:cNvPr>
          <p:cNvSpPr txBox="1"/>
          <p:nvPr/>
        </p:nvSpPr>
        <p:spPr>
          <a:xfrm>
            <a:off x="7434" y="-8281"/>
            <a:ext cx="18741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DATA</a:t>
            </a:r>
          </a:p>
        </p:txBody>
      </p:sp>
      <p:pic>
        <p:nvPicPr>
          <p:cNvPr id="23" name="Picture 22" descr="A close up of a building&#10;&#10;Description automatically generated">
            <a:extLst>
              <a:ext uri="{FF2B5EF4-FFF2-40B4-BE49-F238E27FC236}">
                <a16:creationId xmlns:a16="http://schemas.microsoft.com/office/drawing/2014/main" id="{5494BEA4-1BA9-482A-8254-30AD436684E1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30089" y="606054"/>
            <a:ext cx="3126036" cy="1710608"/>
          </a:xfrm>
          <a:prstGeom prst="rect">
            <a:avLst/>
          </a:prstGeom>
        </p:spPr>
      </p:pic>
      <p:grpSp>
        <p:nvGrpSpPr>
          <p:cNvPr id="6" name="Group 5"/>
          <p:cNvGrpSpPr/>
          <p:nvPr/>
        </p:nvGrpSpPr>
        <p:grpSpPr>
          <a:xfrm>
            <a:off x="579221" y="776452"/>
            <a:ext cx="1053057" cy="1211973"/>
            <a:chOff x="556360" y="935799"/>
            <a:chExt cx="670436" cy="809711"/>
          </a:xfrm>
        </p:grpSpPr>
        <p:grpSp>
          <p:nvGrpSpPr>
            <p:cNvPr id="4" name="Group 3"/>
            <p:cNvGrpSpPr/>
            <p:nvPr/>
          </p:nvGrpSpPr>
          <p:grpSpPr>
            <a:xfrm>
              <a:off x="886744" y="935799"/>
              <a:ext cx="340052" cy="515483"/>
              <a:chOff x="4960213" y="1595436"/>
              <a:chExt cx="340052" cy="515483"/>
            </a:xfrm>
          </p:grpSpPr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6DE0342E-7B20-4603-9883-D16679C09B3F}"/>
                  </a:ext>
                </a:extLst>
              </p:cNvPr>
              <p:cNvSpPr txBox="1"/>
              <p:nvPr/>
            </p:nvSpPr>
            <p:spPr>
              <a:xfrm>
                <a:off x="4960213" y="1595436"/>
                <a:ext cx="340052" cy="1644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RCC4</a:t>
                </a: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CBFD2CF8-39C5-489D-A2DC-579EA0ECB5A9}"/>
                  </a:ext>
                </a:extLst>
              </p:cNvPr>
              <p:cNvSpPr txBox="1"/>
              <p:nvPr/>
            </p:nvSpPr>
            <p:spPr>
              <a:xfrm rot="16200000">
                <a:off x="4945980" y="1904997"/>
                <a:ext cx="236895" cy="15675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EV</a:t>
                </a: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AF84728B-A3B0-48A5-9E02-8E6BD412C008}"/>
                  </a:ext>
                </a:extLst>
              </p:cNvPr>
              <p:cNvSpPr txBox="1"/>
              <p:nvPr/>
            </p:nvSpPr>
            <p:spPr>
              <a:xfrm rot="16200000">
                <a:off x="5018669" y="1830023"/>
                <a:ext cx="405035" cy="15675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GC1</a:t>
                </a:r>
                <a:r>
                  <a:rPr lang="el-G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1" name="TextBox 10"/>
            <p:cNvSpPr txBox="1"/>
            <p:nvPr/>
          </p:nvSpPr>
          <p:spPr>
            <a:xfrm>
              <a:off x="556360" y="1400091"/>
              <a:ext cx="385977" cy="1644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GC1</a:t>
              </a:r>
              <a:r>
                <a:rPr lang="el-GR" sz="10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603306" y="1581011"/>
              <a:ext cx="339031" cy="1644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Lamin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3" name="Straight Connector 42"/>
            <p:cNvCxnSpPr/>
            <p:nvPr/>
          </p:nvCxnSpPr>
          <p:spPr>
            <a:xfrm flipV="1">
              <a:off x="913955" y="1078394"/>
              <a:ext cx="277519" cy="2494"/>
            </a:xfrm>
            <a:prstGeom prst="line">
              <a:avLst/>
            </a:prstGeom>
            <a:ln w="63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" name="TextBox 2"/>
          <p:cNvSpPr txBox="1"/>
          <p:nvPr/>
        </p:nvSpPr>
        <p:spPr>
          <a:xfrm>
            <a:off x="89600" y="2569053"/>
            <a:ext cx="5880978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. S2. </a:t>
            </a:r>
            <a:r>
              <a:rPr lang="en-US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PPARGC1A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re-expression restores the mRNA expression of TCA cycle enzymes. A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RCC4 cells transiently transduced either Ad GFP (EV) or Ad-PGC-1</a:t>
            </a:r>
            <a:r>
              <a:rPr lang="el-GR" sz="1100" dirty="0">
                <a:latin typeface="Arial" panose="020B0604020202020204" pitchFamily="34" charset="0"/>
                <a:cs typeface="Arial" panose="020B0604020202020204" pitchFamily="34" charset="0"/>
              </a:rPr>
              <a:t>α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were harvested and analyzed for the protein expression of PGC-1</a:t>
            </a:r>
            <a:r>
              <a:rPr lang="el-GR" sz="11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Representative mRNA expression of TCA cycle enzymes from RCC4 cells transiently transduced either Ad-GFP or Ad-PGC-1</a:t>
            </a:r>
            <a:r>
              <a:rPr lang="el-GR" sz="11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n=3/group). Data represent 3 independent experiments and error bars are SEM (*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&lt;0.05, **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&lt;0.01, 2 tail student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test). 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0" y="73914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2709139" y="73914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38738" y="1479554"/>
            <a:ext cx="508449" cy="266491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38737" y="1778500"/>
            <a:ext cx="508449" cy="1896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7909889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/>
          <p:cNvSpPr txBox="1"/>
          <p:nvPr/>
        </p:nvSpPr>
        <p:spPr>
          <a:xfrm>
            <a:off x="0" y="76200"/>
            <a:ext cx="18373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3</a:t>
            </a:r>
          </a:p>
        </p:txBody>
      </p:sp>
      <p:pic>
        <p:nvPicPr>
          <p:cNvPr id="27" name="Picture 26" descr="A close up of a logo&#10;&#10;Description automatically generated">
            <a:extLst>
              <a:ext uri="{FF2B5EF4-FFF2-40B4-BE49-F238E27FC236}">
                <a16:creationId xmlns:a16="http://schemas.microsoft.com/office/drawing/2014/main" id="{FAEEE968-CBE2-468C-8E56-AF3506899DA2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0318" y="677923"/>
            <a:ext cx="2740158" cy="1483535"/>
          </a:xfrm>
          <a:prstGeom prst="rect">
            <a:avLst/>
          </a:prstGeom>
        </p:spPr>
      </p:pic>
      <p:pic>
        <p:nvPicPr>
          <p:cNvPr id="28" name="Picture 27" descr="A screenshot of a cell phone&#10;&#10;Description automatically generated">
            <a:extLst>
              <a:ext uri="{FF2B5EF4-FFF2-40B4-BE49-F238E27FC236}">
                <a16:creationId xmlns:a16="http://schemas.microsoft.com/office/drawing/2014/main" id="{9C9FFCC9-32C7-4850-92B5-3F07814BBD2D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61997" y="457769"/>
            <a:ext cx="3082934" cy="1754824"/>
          </a:xfrm>
          <a:prstGeom prst="rect">
            <a:avLst/>
          </a:prstGeom>
        </p:spPr>
      </p:pic>
      <p:grpSp>
        <p:nvGrpSpPr>
          <p:cNvPr id="29" name="Group 28">
            <a:extLst>
              <a:ext uri="{FF2B5EF4-FFF2-40B4-BE49-F238E27FC236}">
                <a16:creationId xmlns:a16="http://schemas.microsoft.com/office/drawing/2014/main" id="{8A291167-76B3-41FD-9CEB-1D77002E0E2E}"/>
              </a:ext>
            </a:extLst>
          </p:cNvPr>
          <p:cNvGrpSpPr/>
          <p:nvPr/>
        </p:nvGrpSpPr>
        <p:grpSpPr>
          <a:xfrm>
            <a:off x="86494" y="2443863"/>
            <a:ext cx="2186474" cy="1388950"/>
            <a:chOff x="254902" y="2248346"/>
            <a:chExt cx="2102793" cy="1332064"/>
          </a:xfrm>
        </p:grpSpPr>
        <p:grpSp>
          <p:nvGrpSpPr>
            <p:cNvPr id="30" name="Group 29">
              <a:extLst>
                <a:ext uri="{FF2B5EF4-FFF2-40B4-BE49-F238E27FC236}">
                  <a16:creationId xmlns:a16="http://schemas.microsoft.com/office/drawing/2014/main" id="{DFF53604-EED4-4F80-8EF1-C70C8156BE5F}"/>
                </a:ext>
              </a:extLst>
            </p:cNvPr>
            <p:cNvGrpSpPr/>
            <p:nvPr/>
          </p:nvGrpSpPr>
          <p:grpSpPr>
            <a:xfrm>
              <a:off x="825982" y="3084221"/>
              <a:ext cx="1531713" cy="496189"/>
              <a:chOff x="614538" y="3067375"/>
              <a:chExt cx="1737022" cy="496189"/>
            </a:xfrm>
          </p:grpSpPr>
          <p:pic>
            <p:nvPicPr>
              <p:cNvPr id="45" name="Picture 44">
                <a:extLst>
                  <a:ext uri="{FF2B5EF4-FFF2-40B4-BE49-F238E27FC236}">
                    <a16:creationId xmlns:a16="http://schemas.microsoft.com/office/drawing/2014/main" id="{C29E574E-8D91-40C5-9455-8CF15E30290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t="12609" b="9919"/>
              <a:stretch/>
            </p:blipFill>
            <p:spPr>
              <a:xfrm>
                <a:off x="614538" y="3067375"/>
                <a:ext cx="1737022" cy="245929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46" name="Picture 45">
                <a:extLst>
                  <a:ext uri="{FF2B5EF4-FFF2-40B4-BE49-F238E27FC236}">
                    <a16:creationId xmlns:a16="http://schemas.microsoft.com/office/drawing/2014/main" id="{75968584-A5F2-4898-97E9-8A2EF15CD0F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614538" y="3376818"/>
                <a:ext cx="1737022" cy="186746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</p:grp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BFEB2C15-1FCE-4EFF-BDDF-54E05DBFA971}"/>
                </a:ext>
              </a:extLst>
            </p:cNvPr>
            <p:cNvSpPr txBox="1"/>
            <p:nvPr/>
          </p:nvSpPr>
          <p:spPr>
            <a:xfrm>
              <a:off x="254902" y="3091605"/>
              <a:ext cx="513365" cy="1817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OL1A1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2E42F9B7-3F46-440F-9356-56E0F3AEC445}"/>
                </a:ext>
              </a:extLst>
            </p:cNvPr>
            <p:cNvSpPr txBox="1"/>
            <p:nvPr/>
          </p:nvSpPr>
          <p:spPr>
            <a:xfrm>
              <a:off x="308657" y="3365847"/>
              <a:ext cx="459610" cy="1817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Tubulin</a:t>
              </a:r>
            </a:p>
          </p:txBody>
        </p:sp>
        <p:grpSp>
          <p:nvGrpSpPr>
            <p:cNvPr id="33" name="Group 32">
              <a:extLst>
                <a:ext uri="{FF2B5EF4-FFF2-40B4-BE49-F238E27FC236}">
                  <a16:creationId xmlns:a16="http://schemas.microsoft.com/office/drawing/2014/main" id="{970630B3-ECA6-4830-94A8-F52E3A01392A}"/>
                </a:ext>
              </a:extLst>
            </p:cNvPr>
            <p:cNvGrpSpPr/>
            <p:nvPr/>
          </p:nvGrpSpPr>
          <p:grpSpPr>
            <a:xfrm>
              <a:off x="845474" y="2571879"/>
              <a:ext cx="684097" cy="580124"/>
              <a:chOff x="845308" y="2538480"/>
              <a:chExt cx="684097" cy="580124"/>
            </a:xfrm>
          </p:grpSpPr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9A6244DF-EEDD-4D21-B691-B10588EE1A39}"/>
                  </a:ext>
                </a:extLst>
              </p:cNvPr>
              <p:cNvSpPr txBox="1"/>
              <p:nvPr/>
            </p:nvSpPr>
            <p:spPr>
              <a:xfrm rot="16200000">
                <a:off x="784613" y="2858528"/>
                <a:ext cx="309045" cy="1876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on</a:t>
                </a: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22B28999-2182-48B4-BDA4-729B37F1752A}"/>
                  </a:ext>
                </a:extLst>
              </p:cNvPr>
              <p:cNvSpPr txBox="1"/>
              <p:nvPr/>
            </p:nvSpPr>
            <p:spPr>
              <a:xfrm rot="16200000">
                <a:off x="912590" y="2731691"/>
                <a:ext cx="574077" cy="1876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B431542</a:t>
                </a:r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3972D76F-ED5C-4D06-A9F4-396308DD3B11}"/>
                  </a:ext>
                </a:extLst>
              </p:cNvPr>
              <p:cNvSpPr txBox="1"/>
              <p:nvPr/>
            </p:nvSpPr>
            <p:spPr>
              <a:xfrm rot="16200000">
                <a:off x="1153863" y="2743062"/>
                <a:ext cx="563429" cy="1876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LY210976</a:t>
                </a:r>
              </a:p>
            </p:txBody>
          </p:sp>
        </p:grpSp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B36A029D-6846-4C92-AB47-C872DFEA27DB}"/>
                </a:ext>
              </a:extLst>
            </p:cNvPr>
            <p:cNvGrpSpPr/>
            <p:nvPr/>
          </p:nvGrpSpPr>
          <p:grpSpPr>
            <a:xfrm>
              <a:off x="1591840" y="2577385"/>
              <a:ext cx="670124" cy="581691"/>
              <a:chOff x="809986" y="2575702"/>
              <a:chExt cx="670124" cy="581691"/>
            </a:xfrm>
          </p:grpSpPr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B0739572-2CE2-4992-BD1B-80285DB37776}"/>
                  </a:ext>
                </a:extLst>
              </p:cNvPr>
              <p:cNvSpPr txBox="1"/>
              <p:nvPr/>
            </p:nvSpPr>
            <p:spPr>
              <a:xfrm rot="16200000">
                <a:off x="749291" y="2909043"/>
                <a:ext cx="309045" cy="18765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on</a:t>
                </a: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CC9FEB8E-B536-4321-81B3-E524912B1F6F}"/>
                  </a:ext>
                </a:extLst>
              </p:cNvPr>
              <p:cNvSpPr txBox="1"/>
              <p:nvPr/>
            </p:nvSpPr>
            <p:spPr>
              <a:xfrm rot="16200000">
                <a:off x="863294" y="2768913"/>
                <a:ext cx="574077" cy="1876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B431542</a:t>
                </a: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5EC08A75-B01D-4E39-8344-8E2602A8B118}"/>
                  </a:ext>
                </a:extLst>
              </p:cNvPr>
              <p:cNvSpPr txBox="1"/>
              <p:nvPr/>
            </p:nvSpPr>
            <p:spPr>
              <a:xfrm rot="16200000">
                <a:off x="1104568" y="2774237"/>
                <a:ext cx="563429" cy="1876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LY210976</a:t>
                </a:r>
              </a:p>
            </p:txBody>
          </p:sp>
        </p:grpSp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C78D862A-C65E-4E3C-88E5-9CCC0AC86E1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33816" y="2435412"/>
              <a:ext cx="501929" cy="298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E0E93CEA-B5AD-4270-AA0D-332AEB6BCBC1}"/>
                </a:ext>
              </a:extLst>
            </p:cNvPr>
            <p:cNvSpPr txBox="1"/>
            <p:nvPr/>
          </p:nvSpPr>
          <p:spPr>
            <a:xfrm>
              <a:off x="957417" y="2262394"/>
              <a:ext cx="454723" cy="1817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AKI-1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5AFA3EC0-8DA2-4849-B84D-70E80DD23367}"/>
                </a:ext>
              </a:extLst>
            </p:cNvPr>
            <p:cNvSpPr txBox="1"/>
            <p:nvPr/>
          </p:nvSpPr>
          <p:spPr>
            <a:xfrm>
              <a:off x="1669812" y="2248346"/>
              <a:ext cx="530469" cy="1817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RXF-393</a:t>
              </a:r>
            </a:p>
          </p:txBody>
        </p:sp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id="{2591574E-4D7C-4B3B-941C-1EA172102362}"/>
                </a:ext>
              </a:extLst>
            </p:cNvPr>
            <p:cNvCxnSpPr>
              <a:cxnSpLocks/>
            </p:cNvCxnSpPr>
            <p:nvPr/>
          </p:nvCxnSpPr>
          <p:spPr>
            <a:xfrm>
              <a:off x="1693415" y="2435412"/>
              <a:ext cx="54864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47" name="TextBox 46"/>
          <p:cNvSpPr txBox="1"/>
          <p:nvPr/>
        </p:nvSpPr>
        <p:spPr>
          <a:xfrm>
            <a:off x="11332" y="62900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2830083" y="62350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11332" y="2316299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3273700" y="2445236"/>
            <a:ext cx="3741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57636" y="4301702"/>
            <a:ext cx="6470431" cy="17851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. S3. Inhibition of </a:t>
            </a:r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TGF</a:t>
            </a:r>
            <a:r>
              <a:rPr lang="en-US" sz="1100" b="1" dirty="0" err="1">
                <a:latin typeface="Symbol" pitchFamily="2" charset="2"/>
                <a:cs typeface="Arial" panose="020B0604020202020204" pitchFamily="34" charset="0"/>
              </a:rPr>
              <a:t>b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signaling suppresses the expression of collagen family members in RCC cells.  A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CAKI-1 cells were treated with either DMSO or indicated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TGF</a:t>
            </a:r>
            <a:r>
              <a:rPr lang="en-US" sz="1100" b="1" dirty="0" err="1">
                <a:latin typeface="Symbol" pitchFamily="2" charset="2"/>
                <a:cs typeface="Arial" panose="020B0604020202020204" pitchFamily="34" charset="0"/>
              </a:rPr>
              <a:t>b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inhibitors (10 </a:t>
            </a:r>
            <a:r>
              <a:rPr lang="el-GR" sz="11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) for 48 h (n=3/group). RNA was isolated and analyzed for the mRNA expression of collagen family members. TBP was used for the normalization of transcript level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Relative mRNA expression of collagen family members in RXF-393 cells treated with either DMSO or indicated TGF</a:t>
            </a:r>
            <a:r>
              <a:rPr lang="el-GR" sz="11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inhibitors (10 </a:t>
            </a:r>
            <a:r>
              <a:rPr lang="el-GR" sz="11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) for 48 h (n=3/group)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Immunoblot analysis of COL1A1 in RCC cells treated with indicated TGF</a:t>
            </a:r>
            <a:r>
              <a:rPr lang="el-GR" sz="11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inhibitors (10 </a:t>
            </a:r>
            <a:r>
              <a:rPr lang="el-GR" sz="11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) for 48 h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D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Relative mRNA expression of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PARGC1A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in RCC cells treated with either DMSO or indicated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TGF</a:t>
            </a:r>
            <a:r>
              <a:rPr lang="en-US" sz="1100" b="1" dirty="0" err="1">
                <a:latin typeface="Symbol" pitchFamily="2" charset="2"/>
                <a:cs typeface="Arial" panose="020B0604020202020204" pitchFamily="34" charset="0"/>
              </a:rPr>
              <a:t>b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inhibitors (10 </a:t>
            </a:r>
            <a:r>
              <a:rPr lang="el-GR" sz="11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) for 48 h (n=3/group). Asterisks indicate differences relative to control ((*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&lt;0.05, **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&lt;0.01,1-way ANOVA with Tukey’s multiple comparisons test). 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99871828"/>
              </p:ext>
            </p:extLst>
          </p:nvPr>
        </p:nvGraphicFramePr>
        <p:xfrm>
          <a:off x="3485319" y="2432386"/>
          <a:ext cx="2252316" cy="210894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91" name="Prism 8" r:id="rId7" imgW="3517085" imgH="3293249" progId="Prism8.Document">
                  <p:embed/>
                </p:oleObj>
              </mc:Choice>
              <mc:Fallback>
                <p:oleObj name="Prism 8" r:id="rId7" imgW="3517085" imgH="3293249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485319" y="2432386"/>
                        <a:ext cx="2252316" cy="210894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3924332" y="2514600"/>
            <a:ext cx="66627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XF393</a:t>
            </a:r>
          </a:p>
        </p:txBody>
      </p:sp>
    </p:spTree>
    <p:extLst>
      <p:ext uri="{BB962C8B-B14F-4D97-AF65-F5344CB8AC3E}">
        <p14:creationId xmlns:p14="http://schemas.microsoft.com/office/powerpoint/2010/main" val="269113430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76200"/>
            <a:ext cx="18806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4.</a:t>
            </a:r>
          </a:p>
        </p:txBody>
      </p:sp>
      <p:graphicFrame>
        <p:nvGraphicFramePr>
          <p:cNvPr id="17" name="Object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51025345"/>
              </p:ext>
            </p:extLst>
          </p:nvPr>
        </p:nvGraphicFramePr>
        <p:xfrm>
          <a:off x="148726" y="761205"/>
          <a:ext cx="2788871" cy="223952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09" name="Prism 8" r:id="rId3" imgW="3360066" imgH="2698634" progId="Prism8.Document">
                  <p:embed/>
                </p:oleObj>
              </mc:Choice>
              <mc:Fallback>
                <p:oleObj name="Prism 8" r:id="rId3" imgW="3360066" imgH="2698634" progId="Prism8.Document">
                  <p:embed/>
                  <p:pic>
                    <p:nvPicPr>
                      <p:cNvPr id="4" name="Object 3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48726" y="761205"/>
                        <a:ext cx="2788871" cy="223952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9" name="TextBox 28"/>
          <p:cNvSpPr txBox="1"/>
          <p:nvPr/>
        </p:nvSpPr>
        <p:spPr>
          <a:xfrm>
            <a:off x="-24788" y="39082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228600" y="3149303"/>
            <a:ext cx="6470431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. S4. HDAC7 represses the expression of TCA cycle enzymes in RCC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) Relative mRNA expression of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HDAC1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HDAC7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in 769-P cells transfected with 20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negative siRNA (NC),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HDAC1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or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 HDAC7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or 72hr (**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&lt;0.01, 2 tail student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test).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ChIP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qPCR was performed on CAKI-1 cells with mouse IgG and anti-HDAC7. The enriched DNA was quantified by qPCR with primer sets targeting the potential SMAD binding sites within 1.5kb upstream of the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SUCLG1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promoter. Enrichment was calculated with the percent input method  (n=2/group, 3 independent experiments).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90509664"/>
              </p:ext>
            </p:extLst>
          </p:nvPr>
        </p:nvGraphicFramePr>
        <p:xfrm>
          <a:off x="4109451" y="705544"/>
          <a:ext cx="2286162" cy="203575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10" name="Prism 8" r:id="rId5" imgW="3463785" imgH="3084359" progId="Prism8.Document">
                  <p:embed/>
                </p:oleObj>
              </mc:Choice>
              <mc:Fallback>
                <p:oleObj name="Prism 8" r:id="rId5" imgW="3463785" imgH="3084359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109451" y="705544"/>
                        <a:ext cx="2286162" cy="203575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8" name="TextBox 17"/>
          <p:cNvSpPr txBox="1"/>
          <p:nvPr/>
        </p:nvSpPr>
        <p:spPr>
          <a:xfrm>
            <a:off x="3581400" y="390819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cxnSp>
        <p:nvCxnSpPr>
          <p:cNvPr id="6" name="Straight Connector 5"/>
          <p:cNvCxnSpPr/>
          <p:nvPr/>
        </p:nvCxnSpPr>
        <p:spPr>
          <a:xfrm>
            <a:off x="4355445" y="2698493"/>
            <a:ext cx="505075" cy="259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>
            <a:off x="4993237" y="2699522"/>
            <a:ext cx="505075" cy="259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" name="Straight Connector 27"/>
          <p:cNvCxnSpPr/>
          <p:nvPr/>
        </p:nvCxnSpPr>
        <p:spPr>
          <a:xfrm>
            <a:off x="5725652" y="2698493"/>
            <a:ext cx="505075" cy="259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4419600" y="2698493"/>
            <a:ext cx="17427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  #4                 #3                      #2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               SBE element</a:t>
            </a:r>
          </a:p>
        </p:txBody>
      </p:sp>
      <p:grpSp>
        <p:nvGrpSpPr>
          <p:cNvPr id="30" name="Group 29"/>
          <p:cNvGrpSpPr/>
          <p:nvPr/>
        </p:nvGrpSpPr>
        <p:grpSpPr>
          <a:xfrm>
            <a:off x="4603438" y="353199"/>
            <a:ext cx="1918060" cy="584398"/>
            <a:chOff x="4935556" y="3110188"/>
            <a:chExt cx="1918060" cy="584398"/>
          </a:xfrm>
        </p:grpSpPr>
        <p:grpSp>
          <p:nvGrpSpPr>
            <p:cNvPr id="31" name="Group 30"/>
            <p:cNvGrpSpPr/>
            <p:nvPr/>
          </p:nvGrpSpPr>
          <p:grpSpPr>
            <a:xfrm>
              <a:off x="4935556" y="3110188"/>
              <a:ext cx="1469711" cy="308006"/>
              <a:chOff x="5100488" y="2896978"/>
              <a:chExt cx="1469711" cy="308006"/>
            </a:xfrm>
          </p:grpSpPr>
          <p:grpSp>
            <p:nvGrpSpPr>
              <p:cNvPr id="34" name="Group 33"/>
              <p:cNvGrpSpPr/>
              <p:nvPr/>
            </p:nvGrpSpPr>
            <p:grpSpPr>
              <a:xfrm>
                <a:off x="5100488" y="2896978"/>
                <a:ext cx="1469711" cy="308006"/>
                <a:chOff x="5097669" y="2941467"/>
                <a:chExt cx="1469711" cy="308006"/>
              </a:xfrm>
            </p:grpSpPr>
            <p:grpSp>
              <p:nvGrpSpPr>
                <p:cNvPr id="39" name="Group 38"/>
                <p:cNvGrpSpPr/>
                <p:nvPr/>
              </p:nvGrpSpPr>
              <p:grpSpPr>
                <a:xfrm>
                  <a:off x="5285794" y="2941467"/>
                  <a:ext cx="1281586" cy="107812"/>
                  <a:chOff x="5237399" y="2941467"/>
                  <a:chExt cx="1281586" cy="107812"/>
                </a:xfrm>
              </p:grpSpPr>
              <p:cxnSp>
                <p:nvCxnSpPr>
                  <p:cNvPr id="42" name="Straight Connector 41"/>
                  <p:cNvCxnSpPr/>
                  <p:nvPr/>
                </p:nvCxnSpPr>
                <p:spPr>
                  <a:xfrm>
                    <a:off x="5237399" y="3044900"/>
                    <a:ext cx="1127173" cy="3788"/>
                  </a:xfrm>
                  <a:prstGeom prst="line">
                    <a:avLst/>
                  </a:prstGeom>
                  <a:ln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3" name="Straight Connector 42"/>
                  <p:cNvCxnSpPr/>
                  <p:nvPr/>
                </p:nvCxnSpPr>
                <p:spPr>
                  <a:xfrm flipV="1">
                    <a:off x="6284623" y="2941467"/>
                    <a:ext cx="234362" cy="3020"/>
                  </a:xfrm>
                  <a:prstGeom prst="line">
                    <a:avLst/>
                  </a:prstGeom>
                  <a:ln>
                    <a:headEnd type="none" w="med" len="med"/>
                    <a:tailEnd type="triangle" w="med" len="med"/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4" name="Straight Connector 43"/>
                  <p:cNvCxnSpPr/>
                  <p:nvPr/>
                </p:nvCxnSpPr>
                <p:spPr>
                  <a:xfrm>
                    <a:off x="6284623" y="2943212"/>
                    <a:ext cx="0" cy="106067"/>
                  </a:xfrm>
                  <a:prstGeom prst="line">
                    <a:avLst/>
                  </a:prstGeom>
                  <a:ln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40" name="TextBox 39"/>
                <p:cNvSpPr txBox="1"/>
                <p:nvPr/>
              </p:nvSpPr>
              <p:spPr>
                <a:xfrm>
                  <a:off x="5482273" y="3049418"/>
                  <a:ext cx="1031051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582/-493/-341/-154 </a:t>
                  </a:r>
                </a:p>
              </p:txBody>
            </p:sp>
            <p:sp>
              <p:nvSpPr>
                <p:cNvPr id="41" name="TextBox 40"/>
                <p:cNvSpPr txBox="1"/>
                <p:nvPr/>
              </p:nvSpPr>
              <p:spPr>
                <a:xfrm>
                  <a:off x="5097669" y="3006266"/>
                  <a:ext cx="359394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1kb</a:t>
                  </a:r>
                </a:p>
              </p:txBody>
            </p:sp>
          </p:grpSp>
          <p:cxnSp>
            <p:nvCxnSpPr>
              <p:cNvPr id="35" name="Straight Connector 34"/>
              <p:cNvCxnSpPr/>
              <p:nvPr/>
            </p:nvCxnSpPr>
            <p:spPr>
              <a:xfrm>
                <a:off x="5749582" y="2949202"/>
                <a:ext cx="391" cy="9144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6" name="Straight Connector 35"/>
              <p:cNvCxnSpPr/>
              <p:nvPr/>
            </p:nvCxnSpPr>
            <p:spPr>
              <a:xfrm>
                <a:off x="5894553" y="2949202"/>
                <a:ext cx="391" cy="9144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7" name="Straight Connector 36"/>
              <p:cNvCxnSpPr/>
              <p:nvPr/>
            </p:nvCxnSpPr>
            <p:spPr>
              <a:xfrm>
                <a:off x="6039524" y="2946726"/>
                <a:ext cx="391" cy="9144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8" name="Straight Connector 37"/>
              <p:cNvCxnSpPr/>
              <p:nvPr/>
            </p:nvCxnSpPr>
            <p:spPr>
              <a:xfrm>
                <a:off x="6226485" y="2941304"/>
                <a:ext cx="391" cy="9144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2" name="TextBox 31"/>
            <p:cNvSpPr txBox="1"/>
            <p:nvPr/>
          </p:nvSpPr>
          <p:spPr>
            <a:xfrm>
              <a:off x="6207285" y="3115265"/>
              <a:ext cx="64633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SUCLG1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5385384" y="3356032"/>
              <a:ext cx="87395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#1 /  2  /  3  / 4</a:t>
              </a:r>
            </a:p>
            <a:p>
              <a:pPr algn="l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 SBE element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5540797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>
        <a:noFill/>
      </a:spPr>
      <a:bodyPr wrap="none" rtlCol="0">
        <a:spAutoFit/>
      </a:bodyPr>
      <a:lstStyle>
        <a:defPPr>
          <a:defRPr sz="800" dirty="0">
            <a:latin typeface="Arial" panose="020B0604020202020204" pitchFamily="34" charset="0"/>
            <a:cs typeface="Arial" panose="020B0604020202020204" pitchFamily="34" charset="0"/>
          </a:defRPr>
        </a:defPPr>
      </a:lstStyle>
    </a:tx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9115</TotalTime>
  <Words>823</Words>
  <Application>Microsoft Office PowerPoint</Application>
  <PresentationFormat>On-screen Show (4:3)</PresentationFormat>
  <Paragraphs>187</Paragraphs>
  <Slides>7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3" baseType="lpstr">
      <vt:lpstr>Arial</vt:lpstr>
      <vt:lpstr>Calibri</vt:lpstr>
      <vt:lpstr>DengXian</vt:lpstr>
      <vt:lpstr>Symbol</vt:lpstr>
      <vt:lpstr>Office Theme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yeyoung Nam</dc:creator>
  <cp:lastModifiedBy>Nam, Hyeyoung (Campus)</cp:lastModifiedBy>
  <cp:revision>571</cp:revision>
  <cp:lastPrinted>2019-02-06T23:40:12Z</cp:lastPrinted>
  <dcterms:created xsi:type="dcterms:W3CDTF">2018-12-14T18:34:22Z</dcterms:created>
  <dcterms:modified xsi:type="dcterms:W3CDTF">2021-02-03T17:13:18Z</dcterms:modified>
</cp:coreProperties>
</file>